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>
        <p:scale>
          <a:sx n="100" d="100"/>
          <a:sy n="100" d="100"/>
        </p:scale>
        <p:origin x="702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6081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6666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3185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4951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0792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5686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9812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445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1787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3834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074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44BC3-4333-4AAC-8292-832F06FB7381}" type="datetimeFigureOut">
              <a:rPr lang="zh-CN" altLang="en-US" smtClean="0"/>
              <a:t>2025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B1798-47E6-4599-8A65-CE4A892E2B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6478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121508" y="659451"/>
            <a:ext cx="1301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2019-5-9</a:t>
            </a:r>
            <a:endParaRPr lang="zh-CN" altLang="en-US" dirty="0"/>
          </a:p>
        </p:txBody>
      </p:sp>
      <p:sp>
        <p:nvSpPr>
          <p:cNvPr id="5" name="左大括号 4"/>
          <p:cNvSpPr/>
          <p:nvPr/>
        </p:nvSpPr>
        <p:spPr>
          <a:xfrm>
            <a:off x="2176585" y="99646"/>
            <a:ext cx="492369" cy="123092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2632605" y="1626845"/>
            <a:ext cx="281374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uterus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7 x 3 x 3.7 cm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follicl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4 x1.3 cm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M: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5cm</a:t>
            </a: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ollicle: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5 x 1.4 x 1.3 cm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668954" y="48160"/>
            <a:ext cx="318399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Estradiol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8.14pg/mL;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Progesterone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28.05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ol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ndometrial thickness: 0.7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ight ovarian corpus luteum, fallopian tube patency normal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121508" y="1928447"/>
            <a:ext cx="13012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2020-4-7</a:t>
            </a:r>
          </a:p>
          <a:p>
            <a:r>
              <a:rPr lang="en-US" altLang="zh-CN" dirty="0" smtClean="0"/>
              <a:t>2020-4-18</a:t>
            </a:r>
            <a:endParaRPr lang="zh-CN" altLang="en-US" dirty="0"/>
          </a:p>
        </p:txBody>
      </p:sp>
      <p:sp>
        <p:nvSpPr>
          <p:cNvPr id="9" name="左大括号 8"/>
          <p:cNvSpPr/>
          <p:nvPr/>
        </p:nvSpPr>
        <p:spPr>
          <a:xfrm>
            <a:off x="2176585" y="1506416"/>
            <a:ext cx="492369" cy="123092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1" name="直接箭头连接符 10"/>
          <p:cNvCxnSpPr/>
          <p:nvPr/>
        </p:nvCxnSpPr>
        <p:spPr>
          <a:xfrm>
            <a:off x="1651000" y="1176772"/>
            <a:ext cx="0" cy="7516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121508" y="1330569"/>
            <a:ext cx="13725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anical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121508" y="3436369"/>
            <a:ext cx="1301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2020-5-12</a:t>
            </a:r>
            <a:endParaRPr lang="zh-CN" altLang="en-US" dirty="0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1651000" y="2606233"/>
            <a:ext cx="0" cy="7516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914198" y="2837076"/>
            <a:ext cx="1735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xtra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t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/>
          <p:cNvCxnSpPr/>
          <p:nvPr/>
        </p:nvCxnSpPr>
        <p:spPr>
          <a:xfrm flipH="1">
            <a:off x="1651000" y="3747673"/>
            <a:ext cx="6838" cy="121802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936668" y="3948000"/>
            <a:ext cx="172192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anicals</a:t>
            </a:r>
          </a:p>
          <a:p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ibao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iaonan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007937" y="4958473"/>
            <a:ext cx="1318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2020-5-12</a:t>
            </a:r>
            <a:endParaRPr lang="zh-CN" altLang="en-US" dirty="0"/>
          </a:p>
        </p:txBody>
      </p:sp>
      <p:sp>
        <p:nvSpPr>
          <p:cNvPr id="22" name="左大括号 21"/>
          <p:cNvSpPr/>
          <p:nvPr/>
        </p:nvSpPr>
        <p:spPr>
          <a:xfrm>
            <a:off x="2172133" y="4789406"/>
            <a:ext cx="492369" cy="707465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2692474" y="4789406"/>
            <a:ext cx="280201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terus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0 x 3.8 x 2.8 cm,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licle 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3 x 1.3x 1.1 cm</a:t>
            </a:r>
            <a:endParaRPr lang="en-US" altLang="zh-CN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EM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cm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5927545" y="1133857"/>
            <a:ext cx="13012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2020-7-6</a:t>
            </a:r>
          </a:p>
          <a:p>
            <a:r>
              <a:rPr lang="en-US" altLang="zh-CN" dirty="0" smtClean="0"/>
              <a:t>2020-7-13</a:t>
            </a:r>
            <a:endParaRPr lang="zh-CN" altLang="en-US" dirty="0"/>
          </a:p>
        </p:txBody>
      </p:sp>
      <p:sp>
        <p:nvSpPr>
          <p:cNvPr id="25" name="左大括号 24"/>
          <p:cNvSpPr/>
          <p:nvPr/>
        </p:nvSpPr>
        <p:spPr>
          <a:xfrm>
            <a:off x="7002030" y="479291"/>
            <a:ext cx="492369" cy="1647369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7475629" y="510643"/>
            <a:ext cx="4616939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H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02 IU/L (follicular phase: 3.03-8.08 IU/L), </a:t>
            </a: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H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97 IU/L (follicular phase: 1.8-11.78 IU/L), </a:t>
            </a: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GN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ol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L (follicular phase: &lt;0.95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ol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L), </a:t>
            </a: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2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2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ol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L (follicular phase: 77.1-921.2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mol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L),</a:t>
            </a: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79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ol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L (reference range: 0.38-1.97 </a:t>
            </a:r>
            <a:r>
              <a:rPr lang="en-US" altLang="zh-CN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ol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L) , </a:t>
            </a: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L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.17 ng/mL (reference range: 5.18-26.33 ng/mL), </a:t>
            </a:r>
            <a:endParaRPr lang="en-US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H-R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72 ng/mL (reference range:0.711-7.59 ng/mL).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5870004" y="4645625"/>
            <a:ext cx="1301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2020-12-16</a:t>
            </a:r>
            <a:endParaRPr lang="zh-CN" altLang="en-US" dirty="0"/>
          </a:p>
        </p:txBody>
      </p:sp>
      <p:sp>
        <p:nvSpPr>
          <p:cNvPr id="28" name="左大括号 27"/>
          <p:cNvSpPr/>
          <p:nvPr/>
        </p:nvSpPr>
        <p:spPr>
          <a:xfrm>
            <a:off x="7236069" y="4444928"/>
            <a:ext cx="492369" cy="790497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/>
          <p:cNvSpPr txBox="1"/>
          <p:nvPr/>
        </p:nvSpPr>
        <p:spPr>
          <a:xfrm>
            <a:off x="7738100" y="4799160"/>
            <a:ext cx="4607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CG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09.3IU/L</a:t>
            </a:r>
          </a:p>
        </p:txBody>
      </p:sp>
      <p:sp>
        <p:nvSpPr>
          <p:cNvPr id="30" name="文本框 29"/>
          <p:cNvSpPr txBox="1"/>
          <p:nvPr/>
        </p:nvSpPr>
        <p:spPr>
          <a:xfrm>
            <a:off x="5956299" y="2722908"/>
            <a:ext cx="1301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2020-10</a:t>
            </a:r>
            <a:endParaRPr lang="zh-CN" altLang="en-US" dirty="0"/>
          </a:p>
        </p:txBody>
      </p:sp>
      <p:sp>
        <p:nvSpPr>
          <p:cNvPr id="31" name="矩形 30"/>
          <p:cNvSpPr/>
          <p:nvPr/>
        </p:nvSpPr>
        <p:spPr>
          <a:xfrm>
            <a:off x="6077013" y="2127025"/>
            <a:ext cx="7745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/>
              <a:t>IVF-ET</a:t>
            </a:r>
            <a:endParaRPr lang="zh-CN" altLang="en-US" dirty="0"/>
          </a:p>
        </p:txBody>
      </p:sp>
      <p:sp>
        <p:nvSpPr>
          <p:cNvPr id="32" name="矩形 31"/>
          <p:cNvSpPr/>
          <p:nvPr/>
        </p:nvSpPr>
        <p:spPr>
          <a:xfrm>
            <a:off x="7102636" y="2772317"/>
            <a:ext cx="35942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M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cm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t eligible for embryo transf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箭头连接符 32"/>
          <p:cNvCxnSpPr/>
          <p:nvPr/>
        </p:nvCxnSpPr>
        <p:spPr>
          <a:xfrm flipH="1">
            <a:off x="6464299" y="1875774"/>
            <a:ext cx="1" cy="8590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矩形 33"/>
          <p:cNvSpPr/>
          <p:nvPr/>
        </p:nvSpPr>
        <p:spPr>
          <a:xfrm>
            <a:off x="6451529" y="3911589"/>
            <a:ext cx="514852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ke 1 g of MRJPs twice daily, morning an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ning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箭头连接符 34"/>
          <p:cNvCxnSpPr/>
          <p:nvPr/>
        </p:nvCxnSpPr>
        <p:spPr>
          <a:xfrm>
            <a:off x="6464300" y="3092240"/>
            <a:ext cx="0" cy="3662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5981699" y="5692571"/>
            <a:ext cx="1301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2021-8-13</a:t>
            </a:r>
            <a:endParaRPr lang="zh-CN" altLang="en-US" dirty="0"/>
          </a:p>
        </p:txBody>
      </p:sp>
      <p:sp>
        <p:nvSpPr>
          <p:cNvPr id="37" name="左大括号 36"/>
          <p:cNvSpPr/>
          <p:nvPr/>
        </p:nvSpPr>
        <p:spPr>
          <a:xfrm>
            <a:off x="7257561" y="5461001"/>
            <a:ext cx="492369" cy="800128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/>
          <p:cNvSpPr/>
          <p:nvPr/>
        </p:nvSpPr>
        <p:spPr>
          <a:xfrm>
            <a:off x="7810780" y="5676399"/>
            <a:ext cx="24300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iv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rth to a baby boy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箭头连接符 38"/>
          <p:cNvCxnSpPr/>
          <p:nvPr/>
        </p:nvCxnSpPr>
        <p:spPr>
          <a:xfrm flipH="1">
            <a:off x="1667025" y="5279883"/>
            <a:ext cx="6838" cy="121802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921233" y="5565730"/>
            <a:ext cx="172192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anicals</a:t>
            </a:r>
          </a:p>
          <a:p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ibao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iaonang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接箭头连接符 41"/>
          <p:cNvCxnSpPr/>
          <p:nvPr/>
        </p:nvCxnSpPr>
        <p:spPr>
          <a:xfrm>
            <a:off x="6464298" y="5014957"/>
            <a:ext cx="0" cy="7516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/>
          <p:cNvCxnSpPr/>
          <p:nvPr/>
        </p:nvCxnSpPr>
        <p:spPr>
          <a:xfrm>
            <a:off x="6464299" y="3641610"/>
            <a:ext cx="0" cy="9527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5927545" y="3370444"/>
            <a:ext cx="1301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2020-11</a:t>
            </a:r>
            <a:endParaRPr lang="zh-CN" altLang="en-US" dirty="0"/>
          </a:p>
        </p:txBody>
      </p:sp>
      <p:sp>
        <p:nvSpPr>
          <p:cNvPr id="44" name="矩形 43"/>
          <p:cNvSpPr/>
          <p:nvPr/>
        </p:nvSpPr>
        <p:spPr>
          <a:xfrm>
            <a:off x="6851584" y="2173794"/>
            <a:ext cx="525438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was diagnosed with Diminished Ovarian 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erve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R</a:t>
            </a:r>
            <a:r>
              <a:rPr lang="zh-CN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7793241" y="4409665"/>
            <a:ext cx="19351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ceiv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turally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31956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4</TotalTime>
  <Words>225</Words>
  <Application>Microsoft Office PowerPoint</Application>
  <PresentationFormat>宽屏</PresentationFormat>
  <Paragraphs>4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福州大学生命科学学院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皮祥友</dc:creator>
  <cp:lastModifiedBy>皮祥友</cp:lastModifiedBy>
  <cp:revision>13</cp:revision>
  <dcterms:created xsi:type="dcterms:W3CDTF">2025-07-14T03:14:33Z</dcterms:created>
  <dcterms:modified xsi:type="dcterms:W3CDTF">2025-10-08T03:29:57Z</dcterms:modified>
</cp:coreProperties>
</file>